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699"/>
    <p:restoredTop sz="94694"/>
  </p:normalViewPr>
  <p:slideViewPr>
    <p:cSldViewPr snapToGrid="0" snapToObjects="1">
      <p:cViewPr varScale="1">
        <p:scale>
          <a:sx n="98" d="100"/>
          <a:sy n="98" d="100"/>
        </p:scale>
        <p:origin x="224" y="7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AW!$V$3</c:f>
              <c:strCache>
                <c:ptCount val="1"/>
                <c:pt idx="0">
                  <c:v> FLAG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AW!$Z$4:$Z$12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1.2440971737681026E-2</c:v>
                  </c:pt>
                  <c:pt idx="2">
                    <c:v>2.3139672522411461E-2</c:v>
                  </c:pt>
                  <c:pt idx="3">
                    <c:v>6.4291005073286427E-3</c:v>
                  </c:pt>
                  <c:pt idx="4">
                    <c:v>2.6034165586355539E-3</c:v>
                  </c:pt>
                  <c:pt idx="5">
                    <c:v>2.6514147167125791E-2</c:v>
                  </c:pt>
                  <c:pt idx="6">
                    <c:v>6.6916199666282351E-3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RAW!$Z$4:$Z$12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1.2440971737681026E-2</c:v>
                  </c:pt>
                  <c:pt idx="2">
                    <c:v>2.3139672522411461E-2</c:v>
                  </c:pt>
                  <c:pt idx="3">
                    <c:v>6.4291005073286427E-3</c:v>
                  </c:pt>
                  <c:pt idx="4">
                    <c:v>2.6034165586355539E-3</c:v>
                  </c:pt>
                  <c:pt idx="5">
                    <c:v>2.6514147167125791E-2</c:v>
                  </c:pt>
                  <c:pt idx="6">
                    <c:v>6.6916199666282351E-3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RAW!$U$4:$U$13</c:f>
              <c:strCache>
                <c:ptCount val="10"/>
                <c:pt idx="0">
                  <c:v>FLAG</c:v>
                </c:pt>
                <c:pt idx="1">
                  <c:v>PPP1R2</c:v>
                </c:pt>
                <c:pt idx="2">
                  <c:v>R2A</c:v>
                </c:pt>
                <c:pt idx="3">
                  <c:v>R2E</c:v>
                </c:pt>
                <c:pt idx="4">
                  <c:v>R2∆N</c:v>
                </c:pt>
                <c:pt idx="5">
                  <c:v>PPP1R2/AURKA</c:v>
                </c:pt>
                <c:pt idx="6">
                  <c:v>PPP1R2/PP1</c:v>
                </c:pt>
                <c:pt idx="7">
                  <c:v>PP1</c:v>
                </c:pt>
                <c:pt idx="8">
                  <c:v>AURKA</c:v>
                </c:pt>
                <c:pt idx="9">
                  <c:v>PP1/AURKA</c:v>
                </c:pt>
              </c:strCache>
            </c:strRef>
          </c:cat>
          <c:val>
            <c:numRef>
              <c:f>RAW!$W$4:$W$13</c:f>
              <c:numCache>
                <c:formatCode>General</c:formatCode>
                <c:ptCount val="10"/>
                <c:pt idx="0">
                  <c:v>0</c:v>
                </c:pt>
                <c:pt idx="1">
                  <c:v>0.26500000000000001</c:v>
                </c:pt>
                <c:pt idx="2">
                  <c:v>0.33199999999999996</c:v>
                </c:pt>
                <c:pt idx="3">
                  <c:v>0.25366666666666665</c:v>
                </c:pt>
                <c:pt idx="4">
                  <c:v>0.33700000000000002</c:v>
                </c:pt>
                <c:pt idx="5">
                  <c:v>0.21366666666666664</c:v>
                </c:pt>
                <c:pt idx="6">
                  <c:v>0.222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837-418B-96F6-53D891C3FB01}"/>
            </c:ext>
          </c:extLst>
        </c:ser>
        <c:ser>
          <c:idx val="1"/>
          <c:order val="1"/>
          <c:tx>
            <c:strRef>
              <c:f>RAW!$X$3</c:f>
              <c:strCache>
                <c:ptCount val="1"/>
                <c:pt idx="0">
                  <c:v> MYC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AW!$AA$4:$AA$13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1.9341952101872013E-2</c:v>
                  </c:pt>
                  <c:pt idx="6">
                    <c:v>7.6883750631138708E-3</c:v>
                  </c:pt>
                  <c:pt idx="7">
                    <c:v>1.3093679560934896E-2</c:v>
                  </c:pt>
                  <c:pt idx="8">
                    <c:v>1.8823743871327334E-2</c:v>
                  </c:pt>
                  <c:pt idx="9">
                    <c:v>8.9876458418085177E-3</c:v>
                  </c:pt>
                </c:numCache>
              </c:numRef>
            </c:plus>
            <c:minus>
              <c:numRef>
                <c:f>RAW!$AA$4:$AA$13</c:f>
                <c:numCache>
                  <c:formatCode>General</c:formatCode>
                  <c:ptCount val="10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1.9341952101872013E-2</c:v>
                  </c:pt>
                  <c:pt idx="6">
                    <c:v>7.6883750631138708E-3</c:v>
                  </c:pt>
                  <c:pt idx="7">
                    <c:v>1.3093679560934896E-2</c:v>
                  </c:pt>
                  <c:pt idx="8">
                    <c:v>1.8823743871327334E-2</c:v>
                  </c:pt>
                  <c:pt idx="9">
                    <c:v>8.9876458418085177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RAW!$U$4:$U$13</c:f>
              <c:strCache>
                <c:ptCount val="10"/>
                <c:pt idx="0">
                  <c:v>FLAG</c:v>
                </c:pt>
                <c:pt idx="1">
                  <c:v>PPP1R2</c:v>
                </c:pt>
                <c:pt idx="2">
                  <c:v>R2A</c:v>
                </c:pt>
                <c:pt idx="3">
                  <c:v>R2E</c:v>
                </c:pt>
                <c:pt idx="4">
                  <c:v>R2∆N</c:v>
                </c:pt>
                <c:pt idx="5">
                  <c:v>PPP1R2/AURKA</c:v>
                </c:pt>
                <c:pt idx="6">
                  <c:v>PPP1R2/PP1</c:v>
                </c:pt>
                <c:pt idx="7">
                  <c:v>PP1</c:v>
                </c:pt>
                <c:pt idx="8">
                  <c:v>AURKA</c:v>
                </c:pt>
                <c:pt idx="9">
                  <c:v>PP1/AURKA</c:v>
                </c:pt>
              </c:strCache>
            </c:strRef>
          </c:cat>
          <c:val>
            <c:numRef>
              <c:f>RAW!$Y$4:$Y$1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696666666666667</c:v>
                </c:pt>
                <c:pt idx="6">
                  <c:v>0.31866666666666671</c:v>
                </c:pt>
                <c:pt idx="7">
                  <c:v>0.33466666666666672</c:v>
                </c:pt>
                <c:pt idx="8">
                  <c:v>0.35033333333333333</c:v>
                </c:pt>
                <c:pt idx="9">
                  <c:v>0.548999999999999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837-418B-96F6-53D891C3FB0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623527840"/>
        <c:axId val="1601759280"/>
      </c:barChart>
      <c:catAx>
        <c:axId val="1623527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1601759280"/>
        <c:crosses val="autoZero"/>
        <c:auto val="1"/>
        <c:lblAlgn val="ctr"/>
        <c:lblOffset val="100"/>
        <c:noMultiLvlLbl val="0"/>
      </c:catAx>
      <c:valAx>
        <c:axId val="16017592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>
                    <a:solidFill>
                      <a:schemeClr val="tx1"/>
                    </a:solidFill>
                  </a:rPr>
                  <a:t>Average</a:t>
                </a:r>
                <a:r>
                  <a:rPr lang="en-US" b="1" baseline="0" dirty="0">
                    <a:solidFill>
                      <a:schemeClr val="tx1"/>
                    </a:solidFill>
                  </a:rPr>
                  <a:t> Absorbance (abs)</a:t>
                </a:r>
                <a:endParaRPr lang="en-US" b="1" dirty="0">
                  <a:solidFill>
                    <a:schemeClr val="tx1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Helvetica" pitchFamily="2" charset="0"/>
                <a:ea typeface="+mn-ea"/>
                <a:cs typeface="+mn-cs"/>
              </a:defRPr>
            </a:pPr>
            <a:endParaRPr lang="en-US"/>
          </a:p>
        </c:txPr>
        <c:crossAx val="16235278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Helvetica" pitchFamily="2" charset="0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50FB7B-E827-8A43-ABE8-AD4CFF3DA8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EEFE0B-3945-3548-BD42-29B98E961D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1684CD-4821-AD48-810F-03D06CD3C7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9ADE91-9F36-3146-ABF9-4B1FA9E073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051416-42F9-A74F-840F-274B3A3E13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56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451C55-4B31-764B-94DF-FBC859B1E4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4DECB8-F3DA-B74B-A882-4774AE3283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D6BC25-8569-EB4E-B39F-40C43CDAE6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7D42A7-EFCD-C04A-A12A-CD3F5DFB3D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4409CB-A2E5-BF47-9F3E-13034F91E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5613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D4696B-BCC3-4145-AFBD-2E3022C3CD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4FD0DC-3E24-2947-BCD8-E6553947BC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ACDF1C-51A1-154A-875B-428BFB3D69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D85C58-36B6-5D47-960D-1305A8070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F3A1CF-D84D-E74C-A9FC-E5C09D435B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513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FAE56B-CF54-634B-9224-052563A387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57730E-F665-6E4C-A290-471AB4BE1C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A34AB4-D536-8949-BF6C-583FCB6AB1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6CBD4A-2F72-204A-9F6A-505508294C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8BC5CD-1C2D-A145-A8B2-D509E6FF8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217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F8417B-3644-C640-9683-FABB17B0E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28C99C-1BD9-2D4D-BBA5-DB353A110C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0EB06D-73DD-214F-9908-60E9B8B25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07BC5D-7443-6A47-BBBF-7A8595808D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197636-CEA9-CC44-A4A5-A60F9FCC48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8992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5C7A64-5A6E-524D-9F72-0455336508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A2E6FA-24C9-014C-A256-B949196392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ACDFC1-795B-A442-BA50-86743CDCAC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F19FA7-384E-E849-8FF4-CACCC2A7A3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FBB429-605D-274D-96A2-54B72C9A3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D40DAE-E6BF-3A4C-8781-DD08CDF75F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33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5F6F3-595E-6549-B5D4-196AD40D19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432DEE-423A-4340-B65C-5B7B6B0B5E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B5174B-4B1F-5649-A2ED-CCF9210D67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CCFA631-1A02-A84D-B55C-BA6763AA18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1A32B93-ACDF-2B4C-902D-8ECA57F67B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7D24AC7-46F1-C344-9E65-B58EADDD86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7E8700-CAA4-CA4C-835B-93B5CDA776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4477C2F-CC0D-644B-B7EC-9D68232F75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0616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7FDAE3-DABA-7846-907E-72CA3309DC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116E22-DE86-1042-952D-7C384DD47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46D52FB-5B27-C74F-90D6-1D5919C34D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A5A48FA-AFAE-E644-9E7D-810DDB1F3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653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82D7C67-5F79-CB48-ABFF-41A06F4C4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7AD7B3A-0FBD-9A45-B750-06C945087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CED6BD3-4828-D047-8924-8AF85BEF2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073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D2A4EB-3ACC-D04E-B88C-F33C931979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95E7F5-6205-EE40-B7A8-2AF440BA86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0AC7D24-812C-F04D-828C-2E142862CA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CBFD46-9823-A642-B7B6-B59DB281A2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086E69-92D8-9C49-B717-5C4E371E7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17B990-25F0-9C43-A5E6-BFAE755DB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72302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0F42C4-3FC7-A741-B39D-10DF5799BC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E02544-EFB2-4343-A73B-CFBBC6E757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F9FE24-B5CC-D24C-AFB0-DA94D15A06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350E6D-BE19-D842-8D76-0887BA1D72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E5E0D3-CCB4-C347-A7BA-BB06320E6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6219D02-50C8-0044-9950-17C8862442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587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5402C44-E6B8-E84D-AF62-572B7F82F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11D970-AAAB-E241-896B-CDD008572A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4FBF9B-8418-F348-BAEF-1906E9CDFC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212759-E88A-9A40-AAF0-DB86EB014A47}" type="datetimeFigureOut">
              <a:rPr lang="en-US" smtClean="0"/>
              <a:t>9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6CBEFA-FB0C-CC43-9033-298BCE675C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F410E0-6698-3E4F-916A-A1B14BFB33D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E3D54-31D2-8D42-9091-AD7A4B853F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089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4">
            <a:extLst>
              <a:ext uri="{FF2B5EF4-FFF2-40B4-BE49-F238E27FC236}">
                <a16:creationId xmlns:a16="http://schemas.microsoft.com/office/drawing/2014/main" id="{1F36FF6D-78AE-4F99-BCCD-2D26B7A9F53A}"/>
              </a:ext>
            </a:extLst>
          </p:cNvPr>
          <p:cNvSpPr txBox="1"/>
          <p:nvPr/>
        </p:nvSpPr>
        <p:spPr>
          <a:xfrm>
            <a:off x="0" y="6522337"/>
            <a:ext cx="18389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800" b="1" dirty="0">
                <a:latin typeface="Helvetica" pitchFamily="2" charset="0"/>
                <a:cs typeface="Arial" panose="020B0604020202020204" pitchFamily="34" charset="0"/>
              </a:rPr>
              <a:t>Additional Fil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8440147-E9ED-4F03-886D-5B79309FCDC3}"/>
              </a:ext>
            </a:extLst>
          </p:cNvPr>
          <p:cNvSpPr txBox="1"/>
          <p:nvPr/>
        </p:nvSpPr>
        <p:spPr>
          <a:xfrm>
            <a:off x="881138" y="43455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 pitchFamily="2" charset="0"/>
              </a:rPr>
              <a:t>A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CE63F90E-0A6C-4116-805B-B67E09D2E15C}"/>
              </a:ext>
            </a:extLst>
          </p:cNvPr>
          <p:cNvGraphicFramePr>
            <a:graphicFrameLocks/>
          </p:cNvGraphicFramePr>
          <p:nvPr/>
        </p:nvGraphicFramePr>
        <p:xfrm>
          <a:off x="1232516" y="254525"/>
          <a:ext cx="6344239" cy="40528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5861AB7A-9794-4168-8D88-B3CD5E67363C}"/>
              </a:ext>
            </a:extLst>
          </p:cNvPr>
          <p:cNvCxnSpPr>
            <a:cxnSpLocks/>
          </p:cNvCxnSpPr>
          <p:nvPr/>
        </p:nvCxnSpPr>
        <p:spPr>
          <a:xfrm>
            <a:off x="1800971" y="402072"/>
            <a:ext cx="6367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D3B3E61-CC05-46AF-9116-B06BC5CFC1AF}"/>
              </a:ext>
            </a:extLst>
          </p:cNvPr>
          <p:cNvCxnSpPr>
            <a:cxnSpLocks/>
          </p:cNvCxnSpPr>
          <p:nvPr/>
        </p:nvCxnSpPr>
        <p:spPr>
          <a:xfrm>
            <a:off x="1802115" y="843909"/>
            <a:ext cx="6367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6465F3CF-26AB-4376-8FEA-0EE7D0E992EF}"/>
              </a:ext>
            </a:extLst>
          </p:cNvPr>
          <p:cNvCxnSpPr>
            <a:cxnSpLocks/>
          </p:cNvCxnSpPr>
          <p:nvPr/>
        </p:nvCxnSpPr>
        <p:spPr>
          <a:xfrm>
            <a:off x="1799821" y="1260013"/>
            <a:ext cx="6367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6C2834D0-4C12-4B04-B3F9-C21004745C95}"/>
              </a:ext>
            </a:extLst>
          </p:cNvPr>
          <p:cNvCxnSpPr>
            <a:cxnSpLocks/>
          </p:cNvCxnSpPr>
          <p:nvPr/>
        </p:nvCxnSpPr>
        <p:spPr>
          <a:xfrm>
            <a:off x="1800967" y="1712160"/>
            <a:ext cx="6367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9C572F18-692C-4C5F-A46F-C92A1B3FB8FD}"/>
              </a:ext>
            </a:extLst>
          </p:cNvPr>
          <p:cNvCxnSpPr>
            <a:cxnSpLocks/>
          </p:cNvCxnSpPr>
          <p:nvPr/>
        </p:nvCxnSpPr>
        <p:spPr>
          <a:xfrm>
            <a:off x="1802107" y="2171956"/>
            <a:ext cx="6367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C6BA0255-DB8F-483E-91AE-97CE9BF77436}"/>
              </a:ext>
            </a:extLst>
          </p:cNvPr>
          <p:cNvCxnSpPr>
            <a:cxnSpLocks/>
          </p:cNvCxnSpPr>
          <p:nvPr/>
        </p:nvCxnSpPr>
        <p:spPr>
          <a:xfrm>
            <a:off x="1797515" y="2605793"/>
            <a:ext cx="6367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525B920-5C13-4AA3-98DF-7A60427BF8C4}"/>
              </a:ext>
            </a:extLst>
          </p:cNvPr>
          <p:cNvCxnSpPr>
            <a:cxnSpLocks/>
          </p:cNvCxnSpPr>
          <p:nvPr/>
        </p:nvCxnSpPr>
        <p:spPr>
          <a:xfrm>
            <a:off x="1802099" y="3043305"/>
            <a:ext cx="6367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50335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8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2</cp:revision>
  <dcterms:created xsi:type="dcterms:W3CDTF">2020-09-15T12:40:11Z</dcterms:created>
  <dcterms:modified xsi:type="dcterms:W3CDTF">2020-09-15T12:45:39Z</dcterms:modified>
</cp:coreProperties>
</file>